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mmune" initials="i" lastIdx="0" clrIdx="0">
    <p:extLst>
      <p:ext uri="{19B8F6BF-5375-455C-9EA6-DF929625EA0E}">
        <p15:presenceInfo xmlns:p15="http://schemas.microsoft.com/office/powerpoint/2012/main" userId="immun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38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1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6858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686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451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1562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5001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3079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276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8910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81009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9128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269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190E6-F2C9-40AB-9097-5A7389FB22E5}" type="datetimeFigureOut">
              <a:rPr lang="ko-KR" altLang="en-US" smtClean="0"/>
              <a:t>2023-03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746CA-AF3B-48C9-8BAC-8ED60C618F4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2828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98628" y="535918"/>
            <a:ext cx="1622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Cathelicidi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05120" y="537968"/>
            <a:ext cx="1200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745664" y="2009620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0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720630" y="2163071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7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720630" y="2360105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5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720630" y="2561897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4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720630" y="2849274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3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20630" y="3107388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2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720630" y="3852132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720630" y="4888419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127164" y="1868576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0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02130" y="2022027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7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102130" y="2219061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5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102130" y="2420853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4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102130" y="2680237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3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102130" y="2975675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2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102130" y="3720419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102130" y="4700722"/>
            <a:ext cx="569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~1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그림 49"/>
          <p:cNvPicPr>
            <a:picLocks noChangeAspect="1"/>
          </p:cNvPicPr>
          <p:nvPr/>
        </p:nvPicPr>
        <p:blipFill rotWithShape="1">
          <a:blip r:embed="rId2"/>
          <a:srcRect b="404"/>
          <a:stretch/>
        </p:blipFill>
        <p:spPr>
          <a:xfrm>
            <a:off x="1713263" y="912971"/>
            <a:ext cx="506012" cy="53128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3" name="그림 5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2945" y="912971"/>
            <a:ext cx="542591" cy="530398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4" name="TextBox 53"/>
          <p:cNvSpPr txBox="1"/>
          <p:nvPr/>
        </p:nvSpPr>
        <p:spPr>
          <a:xfrm>
            <a:off x="1161677" y="1622161"/>
            <a:ext cx="535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762454" y="1752406"/>
            <a:ext cx="5358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307827" y="627508"/>
            <a:ext cx="521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890100" y="627508"/>
            <a:ext cx="8192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en-US" altLang="ko-K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ko-KR" altLang="en-U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931144" y="627508"/>
            <a:ext cx="521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513417" y="627508"/>
            <a:ext cx="8192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en-US" altLang="ko-KR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ko-KR" altLang="en-US" sz="14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-1" y="6550223"/>
            <a:ext cx="10719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rotein expression of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cathelicidin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was decreased in the colon of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  <a:r>
              <a:rPr lang="en-US" altLang="ko-K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mice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5519" y="911929"/>
            <a:ext cx="3627434" cy="531007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42719" y="909923"/>
            <a:ext cx="3682303" cy="531007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562115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60</Words>
  <Application>Microsoft Office PowerPoint</Application>
  <PresentationFormat>와이드스크린</PresentationFormat>
  <Paragraphs>2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Symbo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수민</dc:creator>
  <cp:lastModifiedBy>immune</cp:lastModifiedBy>
  <cp:revision>27</cp:revision>
  <dcterms:created xsi:type="dcterms:W3CDTF">2023-03-22T06:25:57Z</dcterms:created>
  <dcterms:modified xsi:type="dcterms:W3CDTF">2023-03-23T11:25:21Z</dcterms:modified>
</cp:coreProperties>
</file>